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9" r:id="rId3"/>
    <p:sldId id="260" r:id="rId4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1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57"/>
    <a:srgbClr val="FFAC33"/>
    <a:srgbClr val="FF9900"/>
    <a:srgbClr val="FFFF71"/>
    <a:srgbClr val="FFFF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1620" y="66"/>
      </p:cViewPr>
      <p:guideLst>
        <p:guide orient="horz" pos="2141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862" cy="493177"/>
          </a:xfrm>
          <a:prstGeom prst="rect">
            <a:avLst/>
          </a:prstGeom>
        </p:spPr>
        <p:txBody>
          <a:bodyPr vert="horz" lIns="88219" tIns="44110" rIns="88219" bIns="4411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294" y="1"/>
            <a:ext cx="2945862" cy="493177"/>
          </a:xfrm>
          <a:prstGeom prst="rect">
            <a:avLst/>
          </a:prstGeom>
        </p:spPr>
        <p:txBody>
          <a:bodyPr vert="horz" lIns="88219" tIns="44110" rIns="88219" bIns="44110" rtlCol="0"/>
          <a:lstStyle>
            <a:lvl1pPr algn="r">
              <a:defRPr sz="1200"/>
            </a:lvl1pPr>
          </a:lstStyle>
          <a:p>
            <a:fld id="{45E63C5A-ED07-45B6-8FB3-2DAF8B2A634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6138" y="739775"/>
            <a:ext cx="2565400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219" tIns="44110" rIns="88219" bIns="4411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65" y="4689771"/>
            <a:ext cx="5438748" cy="4443183"/>
          </a:xfrm>
          <a:prstGeom prst="rect">
            <a:avLst/>
          </a:prstGeom>
        </p:spPr>
        <p:txBody>
          <a:bodyPr vert="horz" lIns="88219" tIns="44110" rIns="88219" bIns="4411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9543"/>
            <a:ext cx="2945862" cy="493177"/>
          </a:xfrm>
          <a:prstGeom prst="rect">
            <a:avLst/>
          </a:prstGeom>
        </p:spPr>
        <p:txBody>
          <a:bodyPr vert="horz" lIns="88219" tIns="44110" rIns="88219" bIns="4411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294" y="9379543"/>
            <a:ext cx="2945862" cy="493177"/>
          </a:xfrm>
          <a:prstGeom prst="rect">
            <a:avLst/>
          </a:prstGeom>
        </p:spPr>
        <p:txBody>
          <a:bodyPr vert="horz" lIns="88219" tIns="44110" rIns="88219" bIns="44110" rtlCol="0" anchor="b"/>
          <a:lstStyle>
            <a:lvl1pPr algn="r">
              <a:defRPr sz="1200"/>
            </a:lvl1pPr>
          </a:lstStyle>
          <a:p>
            <a:fld id="{E0942741-904B-439A-A70F-66A04886D8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07712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7975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77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071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1995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774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415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0457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400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98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0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3239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A0747-7DAC-47D3-BF6C-AC23646A0422}" type="datetimeFigureOut">
              <a:rPr lang="en-GB" smtClean="0"/>
              <a:t>26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1A6B-3FEB-410D-B2CC-1B6A508DC5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797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jpeg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Documents-Eli\Postdoc\western-blot\2010\10-Mar\100323-PEA3-PD-crop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4686" y="2671280"/>
            <a:ext cx="1810617" cy="118037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D:\Documents-Eli\Postdoc\western-blot\2010\10-Mar\100324-PEA3-mut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4686" y="1125280"/>
            <a:ext cx="1810617" cy="11963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68825" y="8183789"/>
            <a:ext cx="60091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1 Raw data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complete western blots are shown and the areas taken for inclusion in the panels in Fig. 1 are highlighted (indicated by boxes)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63561" y="75771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57310" y="882405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pic>
        <p:nvPicPr>
          <p:cNvPr id="2052" name="Picture 4" descr="D:\Documents-Eli\Postdoc\western-blot\2010\10-Feb\100205-PEA3-wt-mut-RNF4-PD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6880" y="5014643"/>
            <a:ext cx="1431111" cy="143430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D:\Documents-Eli\Postdoc\western-blot\2010\10-Feb\100204-pd-mem-mod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0852" y="6745057"/>
            <a:ext cx="1506493" cy="10921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748638" y="466317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F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" name="Picture 4" descr="D:\Documents-Eli\Postdoc\Sen\Gels\Binding Assay wild type PEA3 attempt 3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9356" y="1073698"/>
            <a:ext cx="1629799" cy="131044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 descr="D:\Documents-Eli\Postdoc\western-blot\2009\09-Apr\090418-RNF4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3829" y="2730403"/>
            <a:ext cx="1606875" cy="161046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30"/>
          <p:cNvSpPr txBox="1"/>
          <p:nvPr/>
        </p:nvSpPr>
        <p:spPr>
          <a:xfrm>
            <a:off x="3473389" y="77493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422401" y="1480483"/>
            <a:ext cx="882650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Rectangle 13"/>
          <p:cNvSpPr/>
          <p:nvPr/>
        </p:nvSpPr>
        <p:spPr>
          <a:xfrm>
            <a:off x="1358900" y="2691705"/>
            <a:ext cx="946151" cy="582462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4246880" y="1080048"/>
            <a:ext cx="581025" cy="538623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/>
          <p:cNvSpPr/>
          <p:nvPr/>
        </p:nvSpPr>
        <p:spPr>
          <a:xfrm>
            <a:off x="5238881" y="1086398"/>
            <a:ext cx="401824" cy="538623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4692968" y="3231424"/>
            <a:ext cx="215714" cy="16495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/>
          <p:cNvSpPr/>
          <p:nvPr/>
        </p:nvSpPr>
        <p:spPr>
          <a:xfrm>
            <a:off x="5150168" y="3206024"/>
            <a:ext cx="215714" cy="16495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/>
          <p:cNvSpPr/>
          <p:nvPr/>
        </p:nvSpPr>
        <p:spPr>
          <a:xfrm>
            <a:off x="4870440" y="5272592"/>
            <a:ext cx="501650" cy="183258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4827244" y="6760826"/>
            <a:ext cx="825500" cy="468877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 Box 12"/>
          <p:cNvSpPr txBox="1">
            <a:spLocks noChangeArrowheads="1"/>
          </p:cNvSpPr>
          <p:nvPr/>
        </p:nvSpPr>
        <p:spPr bwMode="auto">
          <a:xfrm>
            <a:off x="4488143" y="2517516"/>
            <a:ext cx="657552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 RNF4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648086" y="4799199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23" name="Text Box 12"/>
          <p:cNvSpPr txBox="1">
            <a:spLocks noChangeArrowheads="1"/>
          </p:cNvSpPr>
          <p:nvPr/>
        </p:nvSpPr>
        <p:spPr bwMode="auto">
          <a:xfrm>
            <a:off x="803835" y="2434964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149845" y="812198"/>
            <a:ext cx="13019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Coomassie stained gel</a:t>
            </a:r>
          </a:p>
        </p:txBody>
      </p:sp>
      <p:sp>
        <p:nvSpPr>
          <p:cNvPr id="25" name="Text Box 12"/>
          <p:cNvSpPr txBox="1">
            <a:spLocks noChangeArrowheads="1"/>
          </p:cNvSpPr>
          <p:nvPr/>
        </p:nvSpPr>
        <p:spPr bwMode="auto">
          <a:xfrm>
            <a:off x="3935629" y="6506092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 flipH="1">
            <a:off x="846623" y="291675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846623" y="297629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846623" y="309297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>
            <a:off x="846623" y="3207268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837099" y="335480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H="1">
            <a:off x="846623" y="350950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846623" y="369285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846623" y="386192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623579" y="281617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24005" y="289165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41212" y="299238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41212" y="310559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41212" y="325152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41212" y="342317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41212" y="360653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41212" y="376872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21724" y="2711236"/>
            <a:ext cx="30970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 flipH="1">
            <a:off x="838855" y="129080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H="1">
            <a:off x="838855" y="1350345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>
            <a:off x="838855" y="146702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838855" y="158132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829331" y="172886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838855" y="188355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838855" y="206691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H="1">
            <a:off x="838855" y="223597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615811" y="119022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16237" y="126570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33444" y="136643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33444" y="147964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33444" y="162557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33444" y="179723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33444" y="198058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33444" y="214277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13956" y="1085289"/>
            <a:ext cx="30970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 flipH="1">
            <a:off x="3901208" y="135246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H="1">
            <a:off x="3901208" y="1412008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H="1">
            <a:off x="3901208" y="162711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H="1">
            <a:off x="3901208" y="1849359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3678164" y="125188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695797" y="132736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7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695797" y="154557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695797" y="174768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676309" y="1124727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 flipH="1">
            <a:off x="3898033" y="218908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3695797" y="208740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/>
          <p:cNvCxnSpPr/>
          <p:nvPr/>
        </p:nvCxnSpPr>
        <p:spPr>
          <a:xfrm flipH="1">
            <a:off x="3930912" y="339342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3725501" y="331188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/>
          <p:cNvCxnSpPr/>
          <p:nvPr/>
        </p:nvCxnSpPr>
        <p:spPr>
          <a:xfrm flipH="1">
            <a:off x="4089120" y="695790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 flipH="1">
            <a:off x="4089120" y="701744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H="1">
            <a:off x="4089120" y="711031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H="1">
            <a:off x="4089120" y="719603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H="1">
            <a:off x="4089120" y="729833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H="1">
            <a:off x="4089120" y="745065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flipH="1">
            <a:off x="4089120" y="760305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H="1">
            <a:off x="4089120" y="775545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3866076" y="685732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866502" y="693280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883709" y="700972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883709" y="709436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883709" y="719505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883709" y="73643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883709" y="751672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883709" y="766225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864221" y="6752387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/>
          <p:cNvCxnSpPr/>
          <p:nvPr/>
        </p:nvCxnSpPr>
        <p:spPr>
          <a:xfrm flipH="1">
            <a:off x="4137101" y="539789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3931690" y="531635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Picture 4" descr="D:\Documents-Eli\Postdoc\western-blot\2010\10-Feb\100205-PEA3-wt-mut-RNF4-PD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058" y="5026292"/>
            <a:ext cx="1431111" cy="143430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5" descr="D:\Documents-Eli\Postdoc\western-blot\2010\10-Feb\100204-pd-mem-mod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1366" y="6742582"/>
            <a:ext cx="1506493" cy="10921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TextBox 93"/>
          <p:cNvSpPr txBox="1"/>
          <p:nvPr/>
        </p:nvSpPr>
        <p:spPr>
          <a:xfrm>
            <a:off x="574603" y="466317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E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Rectangle 94"/>
          <p:cNvSpPr/>
          <p:nvPr/>
        </p:nvSpPr>
        <p:spPr>
          <a:xfrm>
            <a:off x="1240607" y="5284241"/>
            <a:ext cx="584200" cy="183258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/>
          <p:cNvSpPr/>
          <p:nvPr/>
        </p:nvSpPr>
        <p:spPr>
          <a:xfrm>
            <a:off x="1029042" y="6758351"/>
            <a:ext cx="825500" cy="468877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TextBox 96"/>
          <p:cNvSpPr txBox="1"/>
          <p:nvPr/>
        </p:nvSpPr>
        <p:spPr>
          <a:xfrm>
            <a:off x="1442215" y="4804265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98" name="Text Box 12"/>
          <p:cNvSpPr txBox="1">
            <a:spLocks noChangeArrowheads="1"/>
          </p:cNvSpPr>
          <p:nvPr/>
        </p:nvSpPr>
        <p:spPr bwMode="auto">
          <a:xfrm>
            <a:off x="728453" y="6506092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9" name="Straight Connector 98"/>
          <p:cNvCxnSpPr/>
          <p:nvPr/>
        </p:nvCxnSpPr>
        <p:spPr>
          <a:xfrm flipH="1">
            <a:off x="907323" y="6966879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flipH="1">
            <a:off x="907323" y="702642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flipH="1">
            <a:off x="907323" y="7119289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flipH="1">
            <a:off x="907323" y="720501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flipH="1">
            <a:off x="907323" y="730731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flipH="1">
            <a:off x="907323" y="745963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 flipH="1">
            <a:off x="907323" y="761203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 flipH="1">
            <a:off x="907323" y="776443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/>
          <p:cNvSpPr txBox="1"/>
          <p:nvPr/>
        </p:nvSpPr>
        <p:spPr>
          <a:xfrm>
            <a:off x="684279" y="686630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684705" y="6941781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701912" y="701869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701912" y="710333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701912" y="720402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701912" y="737330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701912" y="752570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701912" y="767123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682424" y="6761364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Straight Connector 115"/>
          <p:cNvCxnSpPr/>
          <p:nvPr/>
        </p:nvCxnSpPr>
        <p:spPr>
          <a:xfrm flipH="1">
            <a:off x="969289" y="541948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763878" y="533794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93149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D:\Documents-Eli\Postdoc\western-blot\2013\130606\130606-PEA3fl-SK11R-RNF4-singl009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7042" y="7038220"/>
            <a:ext cx="2647950" cy="212883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14164" y="46375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Picture 4" descr="D:\Documents-Eli\Postdoc\western-blot\2009\09-Nov\091114-PD-PEA3-RNF4-mut2-16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7206" y="469722"/>
            <a:ext cx="1731294" cy="173515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31"/>
          <p:cNvSpPr txBox="1"/>
          <p:nvPr/>
        </p:nvSpPr>
        <p:spPr>
          <a:xfrm>
            <a:off x="296635" y="23369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5" descr="D:\Documents-Eli\Postdoc\western-blot\2009\09-Nov\091113-PD-PEA3-RNF4-mut2003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64963" y="2460688"/>
            <a:ext cx="2476500" cy="208597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D:\Documents-Eli\Postdoc\western-blot\2009\09-Nov\091113-PEA3-RNF4mut-PD-input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7926" y="507048"/>
            <a:ext cx="1850855" cy="169783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Rectangle 20"/>
          <p:cNvSpPr/>
          <p:nvPr/>
        </p:nvSpPr>
        <p:spPr>
          <a:xfrm>
            <a:off x="1975518" y="1143692"/>
            <a:ext cx="581025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2" name="Picture 2" descr="D:\Documents-Eli\Postdoc\western-blot\2013\130606\130606-PEA3fl-SK11R-RNF4-14and2301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7446" y="7064724"/>
            <a:ext cx="1938338" cy="212883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6" descr="D:\Documents-Eli\Postdoc\western-blot\2013\130607-PD-PEA3FL-SumoK11R-RNF4\130607-PD-PEA3FL-SumoK11R-RNF4-14and23-2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49654" y="4944100"/>
            <a:ext cx="1836954" cy="184792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7" descr="D:\Documents-Eli\Postdoc\western-blot\2013\130607-PD-PEA3FL-SumoK11R-RNF4\130607-PD-PEA3FL-SumoK11R-RNF4-singl2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585" y="4944100"/>
            <a:ext cx="2753823" cy="18377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Rectangle 24"/>
          <p:cNvSpPr/>
          <p:nvPr/>
        </p:nvSpPr>
        <p:spPr>
          <a:xfrm>
            <a:off x="3504286" y="1020007"/>
            <a:ext cx="581025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/>
          <p:cNvSpPr/>
          <p:nvPr/>
        </p:nvSpPr>
        <p:spPr>
          <a:xfrm>
            <a:off x="1783431" y="2478079"/>
            <a:ext cx="1653507" cy="1126777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Text Box 25"/>
          <p:cNvSpPr txBox="1">
            <a:spLocks noChangeArrowheads="1"/>
          </p:cNvSpPr>
          <p:nvPr/>
        </p:nvSpPr>
        <p:spPr bwMode="auto">
          <a:xfrm>
            <a:off x="1890164" y="267530"/>
            <a:ext cx="79861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RNF4(input) 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197"/>
          <p:cNvSpPr txBox="1"/>
          <p:nvPr/>
        </p:nvSpPr>
        <p:spPr>
          <a:xfrm>
            <a:off x="3504286" y="246361"/>
            <a:ext cx="5886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IB:RNF4</a:t>
            </a:r>
          </a:p>
        </p:txBody>
      </p:sp>
      <p:sp>
        <p:nvSpPr>
          <p:cNvPr id="30" name="Rectangle 29"/>
          <p:cNvSpPr/>
          <p:nvPr/>
        </p:nvSpPr>
        <p:spPr>
          <a:xfrm>
            <a:off x="938031" y="5629418"/>
            <a:ext cx="952133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2134117" y="5639084"/>
            <a:ext cx="952133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/>
          <p:cNvSpPr/>
          <p:nvPr/>
        </p:nvSpPr>
        <p:spPr>
          <a:xfrm>
            <a:off x="4517292" y="5635981"/>
            <a:ext cx="615230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/>
          <p:cNvSpPr/>
          <p:nvPr/>
        </p:nvSpPr>
        <p:spPr>
          <a:xfrm>
            <a:off x="5284922" y="5623211"/>
            <a:ext cx="733424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 Box 25"/>
          <p:cNvSpPr txBox="1">
            <a:spLocks noChangeArrowheads="1"/>
          </p:cNvSpPr>
          <p:nvPr/>
        </p:nvSpPr>
        <p:spPr bwMode="auto">
          <a:xfrm>
            <a:off x="1081799" y="4735153"/>
            <a:ext cx="79861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RNF4(input) 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 Box 25"/>
          <p:cNvSpPr txBox="1">
            <a:spLocks noChangeArrowheads="1"/>
          </p:cNvSpPr>
          <p:nvPr/>
        </p:nvSpPr>
        <p:spPr bwMode="auto">
          <a:xfrm>
            <a:off x="4420206" y="4730703"/>
            <a:ext cx="79861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RNF4(input) 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197"/>
          <p:cNvSpPr txBox="1"/>
          <p:nvPr/>
        </p:nvSpPr>
        <p:spPr>
          <a:xfrm>
            <a:off x="2374432" y="4741818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37" name="TextBox 197"/>
          <p:cNvSpPr txBox="1"/>
          <p:nvPr/>
        </p:nvSpPr>
        <p:spPr>
          <a:xfrm>
            <a:off x="5337285" y="4737565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39" name="Rectangle 38"/>
          <p:cNvSpPr/>
          <p:nvPr/>
        </p:nvSpPr>
        <p:spPr>
          <a:xfrm>
            <a:off x="1931668" y="7060866"/>
            <a:ext cx="1353382" cy="703219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tangle 39"/>
          <p:cNvSpPr/>
          <p:nvPr/>
        </p:nvSpPr>
        <p:spPr>
          <a:xfrm>
            <a:off x="5158365" y="7126520"/>
            <a:ext cx="861435" cy="703219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TextBox 40"/>
          <p:cNvSpPr txBox="1"/>
          <p:nvPr/>
        </p:nvSpPr>
        <p:spPr>
          <a:xfrm>
            <a:off x="415926" y="9277042"/>
            <a:ext cx="6383479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2A and C. Raw data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he complete western blots are shown and the areas taken for inclusion </a:t>
            </a:r>
          </a:p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panels in Fig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re highlighted (indicated by boxes)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 Box 12"/>
          <p:cNvSpPr txBox="1">
            <a:spLocks noChangeArrowheads="1"/>
          </p:cNvSpPr>
          <p:nvPr/>
        </p:nvSpPr>
        <p:spPr bwMode="auto">
          <a:xfrm>
            <a:off x="1440029" y="2269415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 Box 12"/>
          <p:cNvSpPr txBox="1">
            <a:spLocks noChangeArrowheads="1"/>
          </p:cNvSpPr>
          <p:nvPr/>
        </p:nvSpPr>
        <p:spPr bwMode="auto">
          <a:xfrm>
            <a:off x="855386" y="6828762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 Box 12"/>
          <p:cNvSpPr txBox="1">
            <a:spLocks noChangeArrowheads="1"/>
          </p:cNvSpPr>
          <p:nvPr/>
        </p:nvSpPr>
        <p:spPr bwMode="auto">
          <a:xfrm>
            <a:off x="4055446" y="6846854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 flipH="1">
            <a:off x="1151139" y="298258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>
            <a:off x="1137640" y="313668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1135615" y="336785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1145827" y="354582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>
            <a:off x="1148807" y="3825325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1145828" y="414274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H="1">
            <a:off x="1145829" y="432789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928241" y="288200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928241" y="305417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945874" y="329901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945874" y="344414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945874" y="372203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945874" y="405641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945874" y="424156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945874" y="2675038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 flipH="1">
            <a:off x="726727" y="127805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526774" y="118273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/>
          <p:cNvCxnSpPr/>
          <p:nvPr/>
        </p:nvCxnSpPr>
        <p:spPr>
          <a:xfrm flipH="1">
            <a:off x="564481" y="738416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 flipH="1">
            <a:off x="563682" y="7503338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 flipH="1">
            <a:off x="561657" y="771227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flipH="1">
            <a:off x="565519" y="788070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flipH="1">
            <a:off x="565324" y="8126859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 flipH="1">
            <a:off x="562345" y="8431565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flipH="1">
            <a:off x="565521" y="873578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341583" y="728358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54283" y="742083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71916" y="763390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365566" y="778537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362454" y="804897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362391" y="834523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65566" y="864945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71916" y="7013117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06"/>
          <p:cNvCxnSpPr/>
          <p:nvPr/>
        </p:nvCxnSpPr>
        <p:spPr>
          <a:xfrm flipH="1">
            <a:off x="4030913" y="746880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 flipH="1">
            <a:off x="4030114" y="758797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 flipH="1">
            <a:off x="4028089" y="779691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flipH="1">
            <a:off x="4031951" y="796534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 flipH="1">
            <a:off x="4031756" y="818927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flipH="1">
            <a:off x="4028777" y="8424128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 flipH="1">
            <a:off x="4031953" y="876327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3808015" y="736822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820715" y="750546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3838348" y="771854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831998" y="787001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828886" y="811138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3828823" y="833780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3831998" y="867694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3838348" y="7097755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7942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160004" y="9285427"/>
            <a:ext cx="634527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2B. Raw data.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he complete western blots are shown and the areas taken for inclusio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panels in Fig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re highlighted (indicated by boxes)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6" descr="D:\Documents-Eli\Postdoc\western-blot\2009\09-Nov\091112-PD-PEA3-RNF4-mut1-4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31" t="2697" r="23151" b="3250"/>
          <a:stretch/>
        </p:blipFill>
        <p:spPr bwMode="auto">
          <a:xfrm>
            <a:off x="879189" y="2580277"/>
            <a:ext cx="2453454" cy="208597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3" descr="D:\Documents-Eli\Postdoc\western-blot\2009\09-Nov\091113-PEA3-RNF4mut-PD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2643" y="499170"/>
            <a:ext cx="1697689" cy="17014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D:\Documents-Eli\Postdoc\western-blot\2009\09-Nov\091113-PEA3-RNF4mut-PD-input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1467" y="532067"/>
            <a:ext cx="1854830" cy="17014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Rectangle 22"/>
          <p:cNvSpPr/>
          <p:nvPr/>
        </p:nvSpPr>
        <p:spPr>
          <a:xfrm>
            <a:off x="1225335" y="2580277"/>
            <a:ext cx="2017550" cy="1259177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/>
          <p:cNvSpPr/>
          <p:nvPr/>
        </p:nvSpPr>
        <p:spPr>
          <a:xfrm>
            <a:off x="3812046" y="1099312"/>
            <a:ext cx="902442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/>
          <p:cNvSpPr/>
          <p:nvPr/>
        </p:nvSpPr>
        <p:spPr>
          <a:xfrm>
            <a:off x="1472905" y="1165106"/>
            <a:ext cx="786126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b="1"/>
          </a:p>
        </p:txBody>
      </p:sp>
      <p:pic>
        <p:nvPicPr>
          <p:cNvPr id="26" name="Picture 2" descr="D:\Documents-Eli\Postdoc\western-blot\2010\10-Feb\100210-PEA3-RNF4-mut-inp4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3465" y="5075075"/>
            <a:ext cx="1697688" cy="170147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3" descr="D:\Documents-Eli\Postdoc\western-blot\2010\10-Feb\100209-mem-RNF4 mut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397" y="7120130"/>
            <a:ext cx="2532293" cy="20970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4" descr="D:\Documents-Eli\Postdoc\western-blot\2010\10-Feb\100210-PEA3-RNF4-mut-PD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1496" y="5053602"/>
            <a:ext cx="1740537" cy="174442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Rectangle 28"/>
          <p:cNvSpPr/>
          <p:nvPr/>
        </p:nvSpPr>
        <p:spPr>
          <a:xfrm>
            <a:off x="706026" y="7196331"/>
            <a:ext cx="1183517" cy="841168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1622785" y="5596052"/>
            <a:ext cx="504825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3657600" y="5510428"/>
            <a:ext cx="601255" cy="172825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Text Box 25"/>
          <p:cNvSpPr txBox="1">
            <a:spLocks noChangeArrowheads="1"/>
          </p:cNvSpPr>
          <p:nvPr/>
        </p:nvSpPr>
        <p:spPr bwMode="auto">
          <a:xfrm>
            <a:off x="1585538" y="296683"/>
            <a:ext cx="79861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RNF4(input) 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197"/>
          <p:cNvSpPr txBox="1"/>
          <p:nvPr/>
        </p:nvSpPr>
        <p:spPr>
          <a:xfrm>
            <a:off x="3944506" y="277394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34" name="Text Box 12"/>
          <p:cNvSpPr txBox="1">
            <a:spLocks noChangeArrowheads="1"/>
          </p:cNvSpPr>
          <p:nvPr/>
        </p:nvSpPr>
        <p:spPr bwMode="auto">
          <a:xfrm>
            <a:off x="990345" y="2364833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 Box 25"/>
          <p:cNvSpPr txBox="1">
            <a:spLocks noChangeArrowheads="1"/>
          </p:cNvSpPr>
          <p:nvPr/>
        </p:nvSpPr>
        <p:spPr bwMode="auto">
          <a:xfrm>
            <a:off x="1490236" y="4856411"/>
            <a:ext cx="798617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RNF4(input) 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197"/>
          <p:cNvSpPr txBox="1"/>
          <p:nvPr/>
        </p:nvSpPr>
        <p:spPr>
          <a:xfrm>
            <a:off x="3736504" y="4822042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D:RNF4</a:t>
            </a:r>
          </a:p>
        </p:txBody>
      </p:sp>
      <p:sp>
        <p:nvSpPr>
          <p:cNvPr id="37" name="Text Box 12"/>
          <p:cNvSpPr txBox="1">
            <a:spLocks noChangeArrowheads="1"/>
          </p:cNvSpPr>
          <p:nvPr/>
        </p:nvSpPr>
        <p:spPr bwMode="auto">
          <a:xfrm>
            <a:off x="734553" y="6906086"/>
            <a:ext cx="225254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b="1" dirty="0" smtClean="0">
                <a:latin typeface="Arial" pitchFamily="34" charset="0"/>
                <a:cs typeface="Arial" pitchFamily="34" charset="0"/>
              </a:rPr>
              <a:t>Ponceau stained nitrocellulose membrane</a:t>
            </a:r>
            <a:endParaRPr lang="en-GB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81041" y="28947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 Left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81041" y="4776528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B Right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 flipH="1">
            <a:off x="770139" y="301433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H="1">
            <a:off x="756640" y="316843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H="1">
            <a:off x="754615" y="3437707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H="1">
            <a:off x="764827" y="365694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H="1">
            <a:off x="767807" y="3974550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>
            <a:off x="764828" y="431736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>
            <a:off x="764829" y="455649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547241" y="291375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47241" y="308592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64874" y="333076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64874" y="356161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564937" y="389666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64874" y="423104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564874" y="447016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64874" y="2706788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 flipH="1">
            <a:off x="1000590" y="1295026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806987" y="119969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/>
          <p:cNvCxnSpPr/>
          <p:nvPr/>
        </p:nvCxnSpPr>
        <p:spPr>
          <a:xfrm flipH="1">
            <a:off x="3234903" y="124172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041300" y="114639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 flipH="1">
            <a:off x="518962" y="749483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flipH="1">
            <a:off x="505463" y="7648934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H="1">
            <a:off x="503438" y="7803895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flipH="1">
            <a:off x="513650" y="795645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H="1">
            <a:off x="516630" y="8145455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flipH="1">
            <a:off x="513651" y="8393011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flipH="1">
            <a:off x="513652" y="865595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296064" y="739425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96064" y="756642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13697" y="769695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13697" y="786112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13760" y="806756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13697" y="830668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13697" y="856962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13697" y="7187288"/>
            <a:ext cx="31290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/>
          <p:cNvCxnSpPr/>
          <p:nvPr/>
        </p:nvCxnSpPr>
        <p:spPr>
          <a:xfrm flipH="1">
            <a:off x="886290" y="5735202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686337" y="563987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H="1">
            <a:off x="3025353" y="5669613"/>
            <a:ext cx="1086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825400" y="557428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879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87</TotalTime>
  <Words>258</Words>
  <Application>Microsoft Office PowerPoint</Application>
  <PresentationFormat>A4 Paper (210x297 mm)</PresentationFormat>
  <Paragraphs>12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Theo Isaac</cp:lastModifiedBy>
  <cp:revision>291</cp:revision>
  <cp:lastPrinted>2016-09-21T15:39:18Z</cp:lastPrinted>
  <dcterms:created xsi:type="dcterms:W3CDTF">2013-03-12T10:39:05Z</dcterms:created>
  <dcterms:modified xsi:type="dcterms:W3CDTF">2017-01-26T12:18:13Z</dcterms:modified>
</cp:coreProperties>
</file>